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3"/>
  </p:notesMasterIdLst>
  <p:sldIdLst>
    <p:sldId id="270" r:id="rId2"/>
    <p:sldId id="277" r:id="rId3"/>
    <p:sldId id="280" r:id="rId4"/>
    <p:sldId id="276" r:id="rId5"/>
    <p:sldId id="292" r:id="rId6"/>
    <p:sldId id="295" r:id="rId7"/>
    <p:sldId id="289" r:id="rId8"/>
    <p:sldId id="288" r:id="rId9"/>
    <p:sldId id="296" r:id="rId10"/>
    <p:sldId id="294" r:id="rId11"/>
    <p:sldId id="297" r:id="rId12"/>
  </p:sldIdLst>
  <p:sldSz cx="6858000" cy="9906000" type="A4"/>
  <p:notesSz cx="6669088" cy="97536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Gunnar Dittmar" initials="GD" lastIdx="6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CC99FF"/>
    <a:srgbClr val="9966FF"/>
    <a:srgbClr val="7F6FC1"/>
    <a:srgbClr val="CC0099"/>
    <a:srgbClr val="FF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292" autoAdjust="0"/>
    <p:restoredTop sz="96529" autoAdjust="0"/>
  </p:normalViewPr>
  <p:slideViewPr>
    <p:cSldViewPr snapToGrid="0">
      <p:cViewPr varScale="1">
        <p:scale>
          <a:sx n="81" d="100"/>
          <a:sy n="81" d="100"/>
        </p:scale>
        <p:origin x="2964" y="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250" cy="4889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lb-L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778250" y="0"/>
            <a:ext cx="2889250" cy="4889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10656C2-8C4E-460D-88FC-2EFFBA5DEEBB}" type="datetimeFigureOut">
              <a:rPr lang="lb-LU" smtClean="0"/>
              <a:t>04/03/2017</a:t>
            </a:fld>
            <a:endParaRPr lang="lb-L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5513" y="1219200"/>
            <a:ext cx="2278062" cy="32924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lb-L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66750" y="4694238"/>
            <a:ext cx="5335588" cy="384016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b-L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264650"/>
            <a:ext cx="2889250" cy="4889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lb-L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778250" y="9264650"/>
            <a:ext cx="2889250" cy="4889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1233EB-16D3-4318-ACBE-018CFB2752CB}" type="slidenum">
              <a:rPr lang="lb-LU" smtClean="0"/>
              <a:t>‹#›</a:t>
            </a:fld>
            <a:endParaRPr lang="lb-LU"/>
          </a:p>
        </p:txBody>
      </p:sp>
    </p:spTree>
    <p:extLst>
      <p:ext uri="{BB962C8B-B14F-4D97-AF65-F5344CB8AC3E}">
        <p14:creationId xmlns:p14="http://schemas.microsoft.com/office/powerpoint/2010/main" val="40179730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lb-L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1233EB-16D3-4318-ACBE-018CFB2752CB}" type="slidenum">
              <a:rPr lang="lb-LU" smtClean="0"/>
              <a:t>1</a:t>
            </a:fld>
            <a:endParaRPr lang="lb-LU"/>
          </a:p>
        </p:txBody>
      </p:sp>
    </p:spTree>
    <p:extLst>
      <p:ext uri="{BB962C8B-B14F-4D97-AF65-F5344CB8AC3E}">
        <p14:creationId xmlns:p14="http://schemas.microsoft.com/office/powerpoint/2010/main" val="51101559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1233EB-16D3-4318-ACBE-018CFB2752CB}" type="slidenum">
              <a:rPr lang="lb-LU" smtClean="0"/>
              <a:t>9</a:t>
            </a:fld>
            <a:endParaRPr lang="lb-LU"/>
          </a:p>
        </p:txBody>
      </p:sp>
    </p:spTree>
    <p:extLst>
      <p:ext uri="{BB962C8B-B14F-4D97-AF65-F5344CB8AC3E}">
        <p14:creationId xmlns:p14="http://schemas.microsoft.com/office/powerpoint/2010/main" val="274182976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1233EB-16D3-4318-ACBE-018CFB2752CB}" type="slidenum">
              <a:rPr lang="lb-LU" smtClean="0"/>
              <a:t>10</a:t>
            </a:fld>
            <a:endParaRPr lang="lb-LU"/>
          </a:p>
        </p:txBody>
      </p:sp>
    </p:spTree>
    <p:extLst>
      <p:ext uri="{BB962C8B-B14F-4D97-AF65-F5344CB8AC3E}">
        <p14:creationId xmlns:p14="http://schemas.microsoft.com/office/powerpoint/2010/main" val="122907915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1233EB-16D3-4318-ACBE-018CFB2752CB}" type="slidenum">
              <a:rPr lang="lb-LU" smtClean="0"/>
              <a:t>11</a:t>
            </a:fld>
            <a:endParaRPr lang="lb-LU"/>
          </a:p>
        </p:txBody>
      </p:sp>
    </p:spTree>
    <p:extLst>
      <p:ext uri="{BB962C8B-B14F-4D97-AF65-F5344CB8AC3E}">
        <p14:creationId xmlns:p14="http://schemas.microsoft.com/office/powerpoint/2010/main" val="22104961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CA97E-9CED-4FAE-852A-0A1502AB9B87}" type="datetimeFigureOut">
              <a:rPr lang="ru-RU" smtClean="0"/>
              <a:t>04.03.2017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355AE-43B8-4A49-8D56-6E233B114766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749205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CA97E-9CED-4FAE-852A-0A1502AB9B87}" type="datetimeFigureOut">
              <a:rPr lang="ru-RU" smtClean="0"/>
              <a:t>04.03.2017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355AE-43B8-4A49-8D56-6E233B114766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5002786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CA97E-9CED-4FAE-852A-0A1502AB9B87}" type="datetimeFigureOut">
              <a:rPr lang="ru-RU" smtClean="0"/>
              <a:t>04.03.2017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355AE-43B8-4A49-8D56-6E233B114766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8137972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CA97E-9CED-4FAE-852A-0A1502AB9B87}" type="datetimeFigureOut">
              <a:rPr lang="ru-RU" smtClean="0"/>
              <a:t>04.03.2017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355AE-43B8-4A49-8D56-6E233B114766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410152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CA97E-9CED-4FAE-852A-0A1502AB9B87}" type="datetimeFigureOut">
              <a:rPr lang="ru-RU" smtClean="0"/>
              <a:t>04.03.2017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355AE-43B8-4A49-8D56-6E233B114766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7494726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CA97E-9CED-4FAE-852A-0A1502AB9B87}" type="datetimeFigureOut">
              <a:rPr lang="ru-RU" smtClean="0"/>
              <a:t>04.03.2017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355AE-43B8-4A49-8D56-6E233B114766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5226313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CA97E-9CED-4FAE-852A-0A1502AB9B87}" type="datetimeFigureOut">
              <a:rPr lang="ru-RU" smtClean="0"/>
              <a:t>04.03.2017</a:t>
            </a:fld>
            <a:endParaRPr lang="ru-R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355AE-43B8-4A49-8D56-6E233B114766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1497273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CA97E-9CED-4FAE-852A-0A1502AB9B87}" type="datetimeFigureOut">
              <a:rPr lang="ru-RU" smtClean="0"/>
              <a:t>04.03.2017</a:t>
            </a:fld>
            <a:endParaRPr lang="ru-R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355AE-43B8-4A49-8D56-6E233B114766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1072072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CA97E-9CED-4FAE-852A-0A1502AB9B87}" type="datetimeFigureOut">
              <a:rPr lang="ru-RU" smtClean="0"/>
              <a:t>04.03.2017</a:t>
            </a:fld>
            <a:endParaRPr lang="ru-R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355AE-43B8-4A49-8D56-6E233B114766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5158782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CA97E-9CED-4FAE-852A-0A1502AB9B87}" type="datetimeFigureOut">
              <a:rPr lang="ru-RU" smtClean="0"/>
              <a:t>04.03.2017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355AE-43B8-4A49-8D56-6E233B114766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2845245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CA97E-9CED-4FAE-852A-0A1502AB9B87}" type="datetimeFigureOut">
              <a:rPr lang="ru-RU" smtClean="0"/>
              <a:t>04.03.2017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355AE-43B8-4A49-8D56-6E233B114766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912230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8CA97E-9CED-4FAE-852A-0A1502AB9B87}" type="datetimeFigureOut">
              <a:rPr lang="ru-RU" smtClean="0"/>
              <a:t>04.03.2017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F355AE-43B8-4A49-8D56-6E233B114766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7459061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46317" y="8099805"/>
            <a:ext cx="641704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ata processing pipeline. The lines show the flow of information between the different parts of the study.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olou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f the lines corresponds to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olou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f the analysis box targeted.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Straight Connector 39"/>
          <p:cNvCxnSpPr>
            <a:stCxn id="83" idx="2"/>
            <a:endCxn id="79" idx="0"/>
          </p:cNvCxnSpPr>
          <p:nvPr/>
        </p:nvCxnSpPr>
        <p:spPr>
          <a:xfrm>
            <a:off x="2758700" y="3630316"/>
            <a:ext cx="1474213" cy="2726670"/>
          </a:xfrm>
          <a:prstGeom prst="line">
            <a:avLst/>
          </a:prstGeom>
          <a:ln>
            <a:solidFill>
              <a:srgbClr val="7030A0"/>
            </a:solidFill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41" name="Straight Connector 40"/>
          <p:cNvCxnSpPr>
            <a:stCxn id="81" idx="2"/>
            <a:endCxn id="67" idx="0"/>
          </p:cNvCxnSpPr>
          <p:nvPr/>
        </p:nvCxnSpPr>
        <p:spPr>
          <a:xfrm>
            <a:off x="1495643" y="3414872"/>
            <a:ext cx="1880023" cy="1672815"/>
          </a:xfrm>
          <a:prstGeom prst="line">
            <a:avLst/>
          </a:prstGeom>
        </p:spPr>
        <p:style>
          <a:lnRef idx="3">
            <a:schemeClr val="accent5"/>
          </a:lnRef>
          <a:fillRef idx="0">
            <a:schemeClr val="accent5"/>
          </a:fillRef>
          <a:effectRef idx="2">
            <a:schemeClr val="accent5"/>
          </a:effectRef>
          <a:fontRef idx="minor">
            <a:schemeClr val="tx1"/>
          </a:fontRef>
        </p:style>
      </p:cxnSp>
      <p:cxnSp>
        <p:nvCxnSpPr>
          <p:cNvPr id="42" name="Straight Connector 41"/>
          <p:cNvCxnSpPr>
            <a:stCxn id="64" idx="2"/>
            <a:endCxn id="67" idx="0"/>
          </p:cNvCxnSpPr>
          <p:nvPr/>
        </p:nvCxnSpPr>
        <p:spPr>
          <a:xfrm flipH="1">
            <a:off x="3375666" y="3847587"/>
            <a:ext cx="782878" cy="1240100"/>
          </a:xfrm>
          <a:prstGeom prst="line">
            <a:avLst/>
          </a:prstGeom>
        </p:spPr>
        <p:style>
          <a:lnRef idx="3">
            <a:schemeClr val="accent5"/>
          </a:lnRef>
          <a:fillRef idx="0">
            <a:schemeClr val="accent5"/>
          </a:fillRef>
          <a:effectRef idx="2">
            <a:schemeClr val="accent5"/>
          </a:effectRef>
          <a:fontRef idx="minor">
            <a:schemeClr val="tx1"/>
          </a:fontRef>
        </p:style>
      </p:cxnSp>
      <p:cxnSp>
        <p:nvCxnSpPr>
          <p:cNvPr id="43" name="Straight Connector 42"/>
          <p:cNvCxnSpPr>
            <a:stCxn id="81" idx="2"/>
            <a:endCxn id="66" idx="0"/>
          </p:cNvCxnSpPr>
          <p:nvPr/>
        </p:nvCxnSpPr>
        <p:spPr>
          <a:xfrm flipH="1">
            <a:off x="1452140" y="3414872"/>
            <a:ext cx="43503" cy="1672814"/>
          </a:xfrm>
          <a:prstGeom prst="line">
            <a:avLst/>
          </a:prstGeom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45" name="Straight Connector 44"/>
          <p:cNvCxnSpPr>
            <a:stCxn id="64" idx="2"/>
            <a:endCxn id="66" idx="0"/>
          </p:cNvCxnSpPr>
          <p:nvPr/>
        </p:nvCxnSpPr>
        <p:spPr>
          <a:xfrm flipH="1">
            <a:off x="1452140" y="3847587"/>
            <a:ext cx="2706404" cy="1240099"/>
          </a:xfrm>
          <a:prstGeom prst="line">
            <a:avLst/>
          </a:prstGeom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46" name="Straight Connector 45"/>
          <p:cNvCxnSpPr>
            <a:stCxn id="65" idx="2"/>
            <a:endCxn id="79" idx="0"/>
          </p:cNvCxnSpPr>
          <p:nvPr/>
        </p:nvCxnSpPr>
        <p:spPr>
          <a:xfrm flipH="1">
            <a:off x="4232913" y="4085555"/>
            <a:ext cx="1511794" cy="2271431"/>
          </a:xfrm>
          <a:prstGeom prst="line">
            <a:avLst/>
          </a:prstGeom>
          <a:ln>
            <a:solidFill>
              <a:srgbClr val="7030A0"/>
            </a:solidFill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47" name="Straight Connector 46"/>
          <p:cNvCxnSpPr>
            <a:stCxn id="83" idx="2"/>
            <a:endCxn id="66" idx="0"/>
          </p:cNvCxnSpPr>
          <p:nvPr/>
        </p:nvCxnSpPr>
        <p:spPr>
          <a:xfrm flipH="1">
            <a:off x="1452140" y="3630316"/>
            <a:ext cx="1306560" cy="1457370"/>
          </a:xfrm>
          <a:prstGeom prst="line">
            <a:avLst/>
          </a:prstGeom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50" name="Straight Connector 49"/>
          <p:cNvCxnSpPr>
            <a:stCxn id="81" idx="2"/>
            <a:endCxn id="78" idx="0"/>
          </p:cNvCxnSpPr>
          <p:nvPr/>
        </p:nvCxnSpPr>
        <p:spPr>
          <a:xfrm>
            <a:off x="1495643" y="3414872"/>
            <a:ext cx="181841" cy="2793869"/>
          </a:xfrm>
          <a:prstGeom prst="line">
            <a:avLst/>
          </a:prstGeom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52" name="Straight Connector 51"/>
          <p:cNvCxnSpPr>
            <a:stCxn id="64" idx="2"/>
            <a:endCxn id="78" idx="0"/>
          </p:cNvCxnSpPr>
          <p:nvPr/>
        </p:nvCxnSpPr>
        <p:spPr>
          <a:xfrm flipH="1">
            <a:off x="1677484" y="3847587"/>
            <a:ext cx="2481060" cy="2361154"/>
          </a:xfrm>
          <a:prstGeom prst="line">
            <a:avLst/>
          </a:prstGeom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53" name="Straight Connector 52"/>
          <p:cNvCxnSpPr>
            <a:stCxn id="81" idx="2"/>
            <a:endCxn id="75" idx="0"/>
          </p:cNvCxnSpPr>
          <p:nvPr/>
        </p:nvCxnSpPr>
        <p:spPr>
          <a:xfrm>
            <a:off x="1495643" y="3414872"/>
            <a:ext cx="3872521" cy="2312192"/>
          </a:xfrm>
          <a:prstGeom prst="line">
            <a:avLst/>
          </a:prstGeom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cxnSp>
        <p:nvCxnSpPr>
          <p:cNvPr id="54" name="Straight Connector 53"/>
          <p:cNvCxnSpPr>
            <a:stCxn id="64" idx="2"/>
            <a:endCxn id="75" idx="0"/>
          </p:cNvCxnSpPr>
          <p:nvPr/>
        </p:nvCxnSpPr>
        <p:spPr>
          <a:xfrm>
            <a:off x="4158544" y="3847587"/>
            <a:ext cx="1209620" cy="1879477"/>
          </a:xfrm>
          <a:prstGeom prst="line">
            <a:avLst/>
          </a:prstGeom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cxnSp>
        <p:nvCxnSpPr>
          <p:cNvPr id="55" name="Straight Connector 54"/>
          <p:cNvCxnSpPr>
            <a:stCxn id="64" idx="2"/>
            <a:endCxn id="77" idx="0"/>
          </p:cNvCxnSpPr>
          <p:nvPr/>
        </p:nvCxnSpPr>
        <p:spPr>
          <a:xfrm>
            <a:off x="4158544" y="3847587"/>
            <a:ext cx="1209620" cy="1249555"/>
          </a:xfrm>
          <a:prstGeom prst="line">
            <a:avLst/>
          </a:prstGeom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56" name="Straight Connector 55"/>
          <p:cNvCxnSpPr>
            <a:stCxn id="81" idx="2"/>
            <a:endCxn id="77" idx="0"/>
          </p:cNvCxnSpPr>
          <p:nvPr/>
        </p:nvCxnSpPr>
        <p:spPr>
          <a:xfrm>
            <a:off x="1495643" y="3414872"/>
            <a:ext cx="3872521" cy="1682270"/>
          </a:xfrm>
          <a:prstGeom prst="line">
            <a:avLst/>
          </a:prstGeom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57" name="Curved Connector 138"/>
          <p:cNvCxnSpPr>
            <a:stCxn id="60" idx="2"/>
            <a:endCxn id="83" idx="0"/>
          </p:cNvCxnSpPr>
          <p:nvPr/>
        </p:nvCxnSpPr>
        <p:spPr>
          <a:xfrm rot="16200000" flipH="1">
            <a:off x="2225799" y="2358750"/>
            <a:ext cx="347873" cy="717929"/>
          </a:xfrm>
          <a:prstGeom prst="curvedConnector3">
            <a:avLst>
              <a:gd name="adj1" fmla="val 50000"/>
            </a:avLst>
          </a:prstGeom>
          <a:ln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58" name="TextBox 57"/>
          <p:cNvSpPr txBox="1"/>
          <p:nvPr/>
        </p:nvSpPr>
        <p:spPr>
          <a:xfrm>
            <a:off x="1160911" y="589397"/>
            <a:ext cx="1757103" cy="954107"/>
          </a:xfrm>
          <a:prstGeom prst="rect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HTA</a:t>
            </a:r>
            <a:br>
              <a:rPr lang="en-US" sz="1400" dirty="0"/>
            </a:br>
            <a:r>
              <a:rPr lang="en-US" sz="1400" dirty="0"/>
              <a:t>(Affymetrix Human Transcriptome</a:t>
            </a:r>
            <a:br>
              <a:rPr lang="en-US" sz="1400" dirty="0"/>
            </a:br>
            <a:r>
              <a:rPr lang="en-US" sz="1400" dirty="0"/>
              <a:t>Array 2.0) CEL files</a:t>
            </a:r>
            <a:endParaRPr lang="ru-RU" sz="1400" dirty="0"/>
          </a:p>
        </p:txBody>
      </p:sp>
      <p:sp>
        <p:nvSpPr>
          <p:cNvPr id="59" name="TextBox 58"/>
          <p:cNvSpPr txBox="1"/>
          <p:nvPr/>
        </p:nvSpPr>
        <p:spPr>
          <a:xfrm>
            <a:off x="4115882" y="587658"/>
            <a:ext cx="1539850" cy="738664"/>
          </a:xfrm>
          <a:prstGeom prst="rect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RNA-seq</a:t>
            </a:r>
            <a:br>
              <a:rPr lang="en-US" sz="1400" b="1" dirty="0"/>
            </a:br>
            <a:r>
              <a:rPr lang="en-US" sz="1400" dirty="0"/>
              <a:t>(Illumina 2000) read libraries</a:t>
            </a:r>
            <a:endParaRPr lang="ru-RU" sz="1400" dirty="0"/>
          </a:p>
        </p:txBody>
      </p:sp>
      <p:sp>
        <p:nvSpPr>
          <p:cNvPr id="60" name="TextBox 59"/>
          <p:cNvSpPr txBox="1"/>
          <p:nvPr/>
        </p:nvSpPr>
        <p:spPr>
          <a:xfrm>
            <a:off x="1358436" y="1805115"/>
            <a:ext cx="1364669" cy="738664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en-US" sz="1400" b="1" i="1" dirty="0"/>
              <a:t>Partek® GS</a:t>
            </a:r>
          </a:p>
          <a:p>
            <a:r>
              <a:rPr lang="en-US" sz="1400" dirty="0"/>
              <a:t>- normalization</a:t>
            </a:r>
          </a:p>
          <a:p>
            <a:r>
              <a:rPr lang="en-US" sz="1400" dirty="0"/>
              <a:t>- summarization</a:t>
            </a:r>
            <a:endParaRPr lang="ru-RU" sz="1400" dirty="0"/>
          </a:p>
        </p:txBody>
      </p:sp>
      <p:sp>
        <p:nvSpPr>
          <p:cNvPr id="61" name="TextBox 60"/>
          <p:cNvSpPr txBox="1"/>
          <p:nvPr/>
        </p:nvSpPr>
        <p:spPr>
          <a:xfrm>
            <a:off x="4115882" y="1515954"/>
            <a:ext cx="1539849" cy="307777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b="1" i="1" dirty="0" err="1"/>
              <a:t>TopHat</a:t>
            </a:r>
            <a:r>
              <a:rPr lang="en-US" sz="1400" b="1" dirty="0"/>
              <a:t> </a:t>
            </a:r>
            <a:r>
              <a:rPr lang="en-US" sz="1400" dirty="0"/>
              <a:t>alignment</a:t>
            </a:r>
            <a:endParaRPr lang="ru-RU" sz="1400" dirty="0"/>
          </a:p>
        </p:txBody>
      </p:sp>
      <p:cxnSp>
        <p:nvCxnSpPr>
          <p:cNvPr id="62" name="Straight Arrow Connector 61"/>
          <p:cNvCxnSpPr>
            <a:stCxn id="59" idx="2"/>
            <a:endCxn id="61" idx="0"/>
          </p:cNvCxnSpPr>
          <p:nvPr/>
        </p:nvCxnSpPr>
        <p:spPr>
          <a:xfrm>
            <a:off x="4885807" y="1326322"/>
            <a:ext cx="0" cy="189632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63" name="TextBox 62"/>
          <p:cNvSpPr txBox="1"/>
          <p:nvPr/>
        </p:nvSpPr>
        <p:spPr>
          <a:xfrm>
            <a:off x="3522141" y="2072729"/>
            <a:ext cx="1272806" cy="954107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b="1" i="1" dirty="0" err="1"/>
              <a:t>HTSeq</a:t>
            </a:r>
            <a:endParaRPr lang="en-US" sz="1400" b="1" i="1" dirty="0"/>
          </a:p>
          <a:p>
            <a:pPr algn="ctr"/>
            <a:r>
              <a:rPr lang="en-US" sz="1400" dirty="0"/>
              <a:t>gene expression estimation</a:t>
            </a:r>
            <a:endParaRPr lang="ru-RU" sz="1400" dirty="0"/>
          </a:p>
        </p:txBody>
      </p:sp>
      <p:sp>
        <p:nvSpPr>
          <p:cNvPr id="64" name="TextBox 63"/>
          <p:cNvSpPr txBox="1"/>
          <p:nvPr/>
        </p:nvSpPr>
        <p:spPr>
          <a:xfrm>
            <a:off x="3568662" y="3324367"/>
            <a:ext cx="1179764" cy="523220"/>
          </a:xfrm>
          <a:prstGeom prst="rect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Counts gene level</a:t>
            </a:r>
            <a:endParaRPr lang="ru-RU" sz="1400" dirty="0"/>
          </a:p>
        </p:txBody>
      </p:sp>
      <p:sp>
        <p:nvSpPr>
          <p:cNvPr id="65" name="TextBox 64"/>
          <p:cNvSpPr txBox="1"/>
          <p:nvPr/>
        </p:nvSpPr>
        <p:spPr>
          <a:xfrm>
            <a:off x="5126472" y="3346891"/>
            <a:ext cx="1236470" cy="738664"/>
          </a:xfrm>
          <a:prstGeom prst="rect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Counts exon/junction level</a:t>
            </a:r>
            <a:endParaRPr lang="ru-RU" sz="1400" dirty="0"/>
          </a:p>
        </p:txBody>
      </p:sp>
      <p:sp>
        <p:nvSpPr>
          <p:cNvPr id="66" name="TextBox 65"/>
          <p:cNvSpPr txBox="1"/>
          <p:nvPr/>
        </p:nvSpPr>
        <p:spPr>
          <a:xfrm>
            <a:off x="523392" y="5087686"/>
            <a:ext cx="1857496" cy="954107"/>
          </a:xfrm>
          <a:prstGeom prst="rect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sz="1400" b="1" dirty="0"/>
              <a:t>Exploratory analysis</a:t>
            </a:r>
          </a:p>
          <a:p>
            <a:r>
              <a:rPr lang="en-US" sz="1400" dirty="0"/>
              <a:t>- PCA</a:t>
            </a:r>
            <a:endParaRPr lang="ru-RU" sz="1400" dirty="0"/>
          </a:p>
          <a:p>
            <a:r>
              <a:rPr lang="en-US" sz="1400" dirty="0"/>
              <a:t>- analysis of variation</a:t>
            </a:r>
          </a:p>
          <a:p>
            <a:r>
              <a:rPr lang="en-US" sz="1400" dirty="0"/>
              <a:t>- Spearman correlation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2437757" y="5087687"/>
            <a:ext cx="1875818" cy="954107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400" b="1" dirty="0"/>
              <a:t>Differential expression analysis</a:t>
            </a:r>
          </a:p>
          <a:p>
            <a:r>
              <a:rPr lang="en-US" sz="1400" dirty="0"/>
              <a:t>- </a:t>
            </a:r>
            <a:r>
              <a:rPr lang="en-US" sz="1400" i="1" dirty="0" err="1"/>
              <a:t>limma</a:t>
            </a:r>
            <a:r>
              <a:rPr lang="en-US" sz="1400" dirty="0"/>
              <a:t> (incl. </a:t>
            </a:r>
            <a:r>
              <a:rPr lang="en-US" sz="1400" i="1" dirty="0" err="1"/>
              <a:t>voom</a:t>
            </a:r>
            <a:r>
              <a:rPr lang="en-US" sz="1400" dirty="0"/>
              <a:t>)</a:t>
            </a:r>
          </a:p>
          <a:p>
            <a:r>
              <a:rPr lang="en-US" sz="1400" dirty="0"/>
              <a:t>- </a:t>
            </a:r>
            <a:r>
              <a:rPr lang="en-US" sz="1400" i="1" dirty="0" err="1"/>
              <a:t>edgeR</a:t>
            </a:r>
            <a:endParaRPr lang="ru-RU" sz="1400" i="1" dirty="0"/>
          </a:p>
        </p:txBody>
      </p:sp>
      <p:cxnSp>
        <p:nvCxnSpPr>
          <p:cNvPr id="68" name="Curved Connector 98"/>
          <p:cNvCxnSpPr>
            <a:stCxn id="60" idx="2"/>
            <a:endCxn id="81" idx="0"/>
          </p:cNvCxnSpPr>
          <p:nvPr/>
        </p:nvCxnSpPr>
        <p:spPr>
          <a:xfrm rot="5400000">
            <a:off x="1594271" y="2445151"/>
            <a:ext cx="347873" cy="545128"/>
          </a:xfrm>
          <a:prstGeom prst="curvedConnector3">
            <a:avLst/>
          </a:prstGeom>
          <a:ln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69" name="TextBox 68"/>
          <p:cNvSpPr txBox="1"/>
          <p:nvPr/>
        </p:nvSpPr>
        <p:spPr>
          <a:xfrm>
            <a:off x="4994437" y="2077592"/>
            <a:ext cx="1363177" cy="954107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b="1" i="1" dirty="0" err="1"/>
              <a:t>featureCounts</a:t>
            </a:r>
            <a:endParaRPr lang="en-US" sz="1400" b="1" i="1" dirty="0"/>
          </a:p>
          <a:p>
            <a:pPr algn="ctr"/>
            <a:r>
              <a:rPr lang="en-US" sz="1400" b="1" dirty="0"/>
              <a:t>(</a:t>
            </a:r>
            <a:r>
              <a:rPr lang="en-US" sz="1400" b="1" i="1" dirty="0" err="1"/>
              <a:t>Rsubread</a:t>
            </a:r>
            <a:r>
              <a:rPr lang="en-US" sz="1400" b="1" dirty="0"/>
              <a:t>)</a:t>
            </a:r>
          </a:p>
          <a:p>
            <a:pPr algn="ctr"/>
            <a:r>
              <a:rPr lang="en-US" sz="1400" dirty="0"/>
              <a:t>exon expression estimation</a:t>
            </a:r>
            <a:endParaRPr lang="ru-RU" sz="1400" dirty="0"/>
          </a:p>
        </p:txBody>
      </p:sp>
      <p:cxnSp>
        <p:nvCxnSpPr>
          <p:cNvPr id="70" name="Curved Connector 121"/>
          <p:cNvCxnSpPr>
            <a:stCxn id="61" idx="2"/>
            <a:endCxn id="63" idx="0"/>
          </p:cNvCxnSpPr>
          <p:nvPr/>
        </p:nvCxnSpPr>
        <p:spPr>
          <a:xfrm rot="5400000">
            <a:off x="4397677" y="1584599"/>
            <a:ext cx="248998" cy="727263"/>
          </a:xfrm>
          <a:prstGeom prst="curvedConnector3">
            <a:avLst/>
          </a:prstGeom>
          <a:ln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71" name="Curved Connector 122"/>
          <p:cNvCxnSpPr>
            <a:stCxn id="61" idx="2"/>
            <a:endCxn id="69" idx="0"/>
          </p:cNvCxnSpPr>
          <p:nvPr/>
        </p:nvCxnSpPr>
        <p:spPr>
          <a:xfrm rot="16200000" flipH="1">
            <a:off x="5153986" y="1555551"/>
            <a:ext cx="253861" cy="790219"/>
          </a:xfrm>
          <a:prstGeom prst="curvedConnector3">
            <a:avLst/>
          </a:prstGeom>
          <a:ln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73" name="Straight Arrow Connector 72"/>
          <p:cNvCxnSpPr>
            <a:stCxn id="63" idx="2"/>
            <a:endCxn id="64" idx="0"/>
          </p:cNvCxnSpPr>
          <p:nvPr/>
        </p:nvCxnSpPr>
        <p:spPr>
          <a:xfrm>
            <a:off x="4158544" y="3026836"/>
            <a:ext cx="0" cy="297531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74" name="Straight Arrow Connector 73"/>
          <p:cNvCxnSpPr>
            <a:stCxn id="69" idx="2"/>
            <a:endCxn id="65" idx="0"/>
          </p:cNvCxnSpPr>
          <p:nvPr/>
        </p:nvCxnSpPr>
        <p:spPr>
          <a:xfrm>
            <a:off x="5676026" y="3031699"/>
            <a:ext cx="68681" cy="315192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75" name="TextBox 74"/>
          <p:cNvSpPr txBox="1"/>
          <p:nvPr/>
        </p:nvSpPr>
        <p:spPr>
          <a:xfrm>
            <a:off x="4430255" y="5727064"/>
            <a:ext cx="1875818" cy="523220"/>
          </a:xfrm>
          <a:prstGeom prst="rect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400" b="1" dirty="0"/>
              <a:t>Prediction analysis</a:t>
            </a:r>
          </a:p>
          <a:p>
            <a:r>
              <a:rPr lang="en-US" sz="1400" dirty="0"/>
              <a:t>- AUC calculation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4430255" y="5097142"/>
            <a:ext cx="1875818" cy="523220"/>
          </a:xfrm>
          <a:prstGeom prst="rect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400" b="1" dirty="0"/>
              <a:t>Detection limits and dynamic range </a:t>
            </a:r>
            <a:endParaRPr lang="ru-RU" sz="1400" dirty="0"/>
          </a:p>
        </p:txBody>
      </p:sp>
      <p:sp>
        <p:nvSpPr>
          <p:cNvPr id="78" name="TextBox 77"/>
          <p:cNvSpPr txBox="1"/>
          <p:nvPr/>
        </p:nvSpPr>
        <p:spPr>
          <a:xfrm>
            <a:off x="527715" y="6208741"/>
            <a:ext cx="2299537" cy="738664"/>
          </a:xfrm>
          <a:prstGeom prst="rect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400" b="1" dirty="0"/>
              <a:t>Functional enrichment</a:t>
            </a:r>
          </a:p>
          <a:p>
            <a:r>
              <a:rPr lang="en-US" sz="1400" dirty="0"/>
              <a:t>- enriched of gene ontology terms with significant genes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3013246" y="6356986"/>
            <a:ext cx="2439333" cy="954107"/>
          </a:xfrm>
          <a:prstGeom prst="rect">
            <a:avLst/>
          </a:prstGeom>
          <a:solidFill>
            <a:srgbClr val="CC99FF"/>
          </a:solidFill>
          <a:ln>
            <a:solidFill>
              <a:srgbClr val="7030A0"/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400" b="1" dirty="0"/>
              <a:t>Splicing analysis</a:t>
            </a:r>
          </a:p>
          <a:p>
            <a:r>
              <a:rPr lang="en-US" sz="1400" i="1" dirty="0" err="1"/>
              <a:t>DEXSeq</a:t>
            </a:r>
            <a:r>
              <a:rPr lang="en-US" sz="1400" dirty="0"/>
              <a:t> and </a:t>
            </a:r>
            <a:r>
              <a:rPr lang="en-US" sz="1400" i="1" dirty="0" err="1"/>
              <a:t>diffSplice</a:t>
            </a:r>
            <a:r>
              <a:rPr lang="en-US" sz="1400" dirty="0"/>
              <a:t> </a:t>
            </a:r>
          </a:p>
          <a:p>
            <a:r>
              <a:rPr lang="en-US" sz="1400" dirty="0"/>
              <a:t>based on exon and junction expression</a:t>
            </a:r>
          </a:p>
        </p:txBody>
      </p:sp>
      <p:cxnSp>
        <p:nvCxnSpPr>
          <p:cNvPr id="80" name="Straight Arrow Connector 79"/>
          <p:cNvCxnSpPr>
            <a:stCxn id="58" idx="2"/>
            <a:endCxn id="60" idx="0"/>
          </p:cNvCxnSpPr>
          <p:nvPr/>
        </p:nvCxnSpPr>
        <p:spPr>
          <a:xfrm>
            <a:off x="2039463" y="1543504"/>
            <a:ext cx="1308" cy="261611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81" name="TextBox 80"/>
          <p:cNvSpPr txBox="1"/>
          <p:nvPr/>
        </p:nvSpPr>
        <p:spPr>
          <a:xfrm>
            <a:off x="1047012" y="2891652"/>
            <a:ext cx="897261" cy="523220"/>
          </a:xfrm>
          <a:prstGeom prst="rect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HTA gene level</a:t>
            </a:r>
            <a:endParaRPr lang="ru-RU" sz="1400" dirty="0"/>
          </a:p>
        </p:txBody>
      </p:sp>
      <p:sp>
        <p:nvSpPr>
          <p:cNvPr id="83" name="TextBox 82"/>
          <p:cNvSpPr txBox="1"/>
          <p:nvPr/>
        </p:nvSpPr>
        <p:spPr>
          <a:xfrm>
            <a:off x="2141733" y="2891652"/>
            <a:ext cx="1233933" cy="738664"/>
          </a:xfrm>
          <a:prstGeom prst="rect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HTA exon/junction level</a:t>
            </a:r>
            <a:endParaRPr lang="ru-RU" sz="1400" dirty="0"/>
          </a:p>
        </p:txBody>
      </p:sp>
    </p:spTree>
    <p:extLst>
      <p:ext uri="{BB962C8B-B14F-4D97-AF65-F5344CB8AC3E}">
        <p14:creationId xmlns:p14="http://schemas.microsoft.com/office/powerpoint/2010/main" val="290549603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3241" y="43031"/>
            <a:ext cx="5764561" cy="7116205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378433" y="7342545"/>
            <a:ext cx="608584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0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ensitivity of differential exon usage analysis to gene expression (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and overlaps between differentially expressed and differentially spliced genes in RNA-seq (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and HTA (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. The difference in dynamic range between platforms (visible in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was normalized by considering quantiles in (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. The fold-change threshold of differentially used exons was set constant.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507945" y="39224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465056" y="405763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01220" y="375888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302214" y="3758883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148080" y="4196080"/>
            <a:ext cx="8066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NA-seq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094480" y="4196080"/>
            <a:ext cx="4810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TA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148080" y="6789643"/>
            <a:ext cx="185756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xons: log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FDR)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094480" y="6789643"/>
            <a:ext cx="185756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xons: log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FDR)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6200000">
            <a:off x="-253056" y="5132558"/>
            <a:ext cx="185756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Jaccard index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6200000">
            <a:off x="2626525" y="5131572"/>
            <a:ext cx="185756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Jaccard index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16200000">
            <a:off x="-296759" y="1511519"/>
            <a:ext cx="185756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umber of spliced exons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 rot="16200000">
            <a:off x="2623374" y="1498002"/>
            <a:ext cx="185756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umber of spliced exons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148080" y="3272424"/>
            <a:ext cx="185756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verage gene expression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4022396" y="3272424"/>
            <a:ext cx="2114243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Quantiles of gene expression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970256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266292" y="3172347"/>
            <a:ext cx="608584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1.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GO enrichment (FDR&lt;0.01) based on all genes identified as spliced by analysis of both exons and junctions within RNA-seq and HTA platforms (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. In (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, the results of functional annotation of the core 207 genes consistently identified as spliced by both platforms and both measures are presented. 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837957" y="312444"/>
            <a:ext cx="1646027" cy="2532810"/>
            <a:chOff x="939354" y="624871"/>
            <a:chExt cx="1646027" cy="2532810"/>
          </a:xfrm>
        </p:grpSpPr>
        <p:sp>
          <p:nvSpPr>
            <p:cNvPr id="4" name="TextBox 3"/>
            <p:cNvSpPr txBox="1"/>
            <p:nvPr/>
          </p:nvSpPr>
          <p:spPr>
            <a:xfrm>
              <a:off x="939354" y="624871"/>
              <a:ext cx="164602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/>
                <a:t>GO categories enriched</a:t>
              </a:r>
              <a:br>
                <a:rPr lang="en-US" sz="1200" dirty="0"/>
              </a:br>
              <a:r>
                <a:rPr lang="en-US" sz="1200" dirty="0"/>
                <a:t>by spliced genes</a:t>
              </a:r>
              <a:endParaRPr lang="en-GB" sz="1200" dirty="0"/>
            </a:p>
          </p:txBody>
        </p:sp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652491" y="1396283"/>
              <a:ext cx="2108340" cy="1414456"/>
            </a:xfrm>
            <a:prstGeom prst="rect">
              <a:avLst/>
            </a:prstGeom>
          </p:spPr>
        </p:pic>
        <p:sp>
          <p:nvSpPr>
            <p:cNvPr id="6" name="Rectangle 46"/>
            <p:cNvSpPr>
              <a:spLocks noChangeArrowheads="1"/>
            </p:cNvSpPr>
            <p:nvPr/>
          </p:nvSpPr>
          <p:spPr bwMode="auto">
            <a:xfrm>
              <a:off x="1512291" y="1251668"/>
              <a:ext cx="397545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fr-FR" altLang="fr-FR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BP: 5</a:t>
              </a:r>
            </a:p>
            <a:p>
              <a:pPr lvl="0"/>
              <a:r>
                <a:rPr lang="fr-FR" altLang="fr-FR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MF: 8</a:t>
              </a:r>
            </a:p>
            <a:p>
              <a:pPr lvl="0"/>
              <a:r>
                <a:rPr lang="fr-FR" altLang="fr-FR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CC: 32</a:t>
              </a:r>
            </a:p>
          </p:txBody>
        </p:sp>
        <p:sp>
          <p:nvSpPr>
            <p:cNvPr id="7" name="Rectangle 46"/>
            <p:cNvSpPr>
              <a:spLocks noChangeArrowheads="1"/>
            </p:cNvSpPr>
            <p:nvPr/>
          </p:nvSpPr>
          <p:spPr bwMode="auto">
            <a:xfrm>
              <a:off x="1469418" y="1891276"/>
              <a:ext cx="405560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BP: 16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altLang="fr-FR" sz="10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MF: 22</a:t>
              </a: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altLang="fr-FR" sz="10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CC: 46</a:t>
              </a:r>
            </a:p>
          </p:txBody>
        </p:sp>
        <p:sp>
          <p:nvSpPr>
            <p:cNvPr id="8" name="Rectangle 7"/>
            <p:cNvSpPr>
              <a:spLocks noChangeArrowheads="1"/>
            </p:cNvSpPr>
            <p:nvPr/>
          </p:nvSpPr>
          <p:spPr bwMode="auto">
            <a:xfrm>
              <a:off x="1477433" y="2546055"/>
              <a:ext cx="397545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fr-FR" altLang="fr-FR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BP: 89</a:t>
              </a:r>
            </a:p>
            <a:p>
              <a:pPr lvl="0"/>
              <a:r>
                <a:rPr lang="fr-FR" altLang="fr-FR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MF: 12</a:t>
              </a:r>
            </a:p>
            <a:p>
              <a:pPr lvl="0"/>
              <a:r>
                <a:rPr lang="fr-FR" altLang="fr-FR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CC: 44</a:t>
              </a:r>
            </a:p>
          </p:txBody>
        </p:sp>
      </p:grpSp>
      <p:sp>
        <p:nvSpPr>
          <p:cNvPr id="12" name="TextBox 11"/>
          <p:cNvSpPr txBox="1"/>
          <p:nvPr/>
        </p:nvSpPr>
        <p:spPr>
          <a:xfrm rot="16200000">
            <a:off x="435783" y="1323962"/>
            <a:ext cx="727672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0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NA-</a:t>
            </a:r>
            <a:r>
              <a:rPr lang="en-US" sz="1000" b="1" dirty="0" err="1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endParaRPr lang="en-US" sz="900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6200000">
            <a:off x="601716" y="2059891"/>
            <a:ext cx="386065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000" b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TA</a:t>
            </a:r>
            <a:endParaRPr lang="en-US" sz="9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419324" y="340457"/>
            <a:ext cx="28405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88063" y="840212"/>
            <a:ext cx="3335822" cy="2005042"/>
          </a:xfrm>
          <a:prstGeom prst="rect">
            <a:avLst/>
          </a:prstGeom>
        </p:spPr>
      </p:pic>
      <p:sp>
        <p:nvSpPr>
          <p:cNvPr id="26" name="Rectangle 25"/>
          <p:cNvSpPr/>
          <p:nvPr/>
        </p:nvSpPr>
        <p:spPr>
          <a:xfrm>
            <a:off x="2888063" y="340457"/>
            <a:ext cx="2936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ectangle 26"/>
          <p:cNvSpPr/>
          <p:nvPr/>
        </p:nvSpPr>
        <p:spPr>
          <a:xfrm>
            <a:off x="2764734" y="339685"/>
            <a:ext cx="3429000" cy="461665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sz="1200" dirty="0">
                <a:cs typeface="Arial" panose="020B0604020202020204" pitchFamily="34" charset="0"/>
              </a:rPr>
              <a:t>GO biological processes enriched</a:t>
            </a:r>
          </a:p>
          <a:p>
            <a:pPr algn="ctr"/>
            <a:r>
              <a:rPr lang="en-US" sz="1200" dirty="0">
                <a:cs typeface="Arial" panose="020B0604020202020204" pitchFamily="34" charset="0"/>
              </a:rPr>
              <a:t>by 207 consistently spliced genes</a:t>
            </a:r>
            <a:endParaRPr lang="en-GB" sz="12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155305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63795" y="4333398"/>
            <a:ext cx="54929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.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Number of mapped reads after RNA-seq analysis of the samples, including </a:t>
            </a:r>
            <a:r>
              <a:rPr lang="en-GB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TopHat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alignment. In general, normal tissues (green) show more reproducible mapping results than tumours (yellow).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3795" y="560302"/>
            <a:ext cx="5492972" cy="36335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20489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80713" y="6338276"/>
            <a:ext cx="529430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enes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, 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and exons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, 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for protein coding and long non-coding RNAs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lncRNA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presented by the platforms after remapping of HTA probes to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nsemb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GRCh37 genome. 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 rot="16200000">
            <a:off x="703994" y="1401543"/>
            <a:ext cx="647614" cy="184666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12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NA-seq</a:t>
            </a:r>
          </a:p>
        </p:txBody>
      </p:sp>
      <p:sp>
        <p:nvSpPr>
          <p:cNvPr id="4" name="TextBox 3"/>
          <p:cNvSpPr txBox="1"/>
          <p:nvPr/>
        </p:nvSpPr>
        <p:spPr>
          <a:xfrm rot="16200000">
            <a:off x="875611" y="2315279"/>
            <a:ext cx="304379" cy="184666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1200" b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TA</a:t>
            </a:r>
          </a:p>
        </p:txBody>
      </p:sp>
      <p:grpSp>
        <p:nvGrpSpPr>
          <p:cNvPr id="5" name="Group 4"/>
          <p:cNvGrpSpPr/>
          <p:nvPr/>
        </p:nvGrpSpPr>
        <p:grpSpPr>
          <a:xfrm>
            <a:off x="1197352" y="661846"/>
            <a:ext cx="1519327" cy="2378235"/>
            <a:chOff x="1543815" y="798805"/>
            <a:chExt cx="1519327" cy="2378235"/>
          </a:xfrm>
        </p:grpSpPr>
        <p:sp>
          <p:nvSpPr>
            <p:cNvPr id="6" name="TextBox 5"/>
            <p:cNvSpPr txBox="1"/>
            <p:nvPr/>
          </p:nvSpPr>
          <p:spPr>
            <a:xfrm>
              <a:off x="1543815" y="798805"/>
              <a:ext cx="15193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/>
                <a:t>protein coding mRNA</a:t>
              </a:r>
              <a:endParaRPr lang="en-GB" sz="1200" dirty="0"/>
            </a:p>
          </p:txBody>
        </p:sp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1215196" y="1415642"/>
              <a:ext cx="2108340" cy="1414456"/>
            </a:xfrm>
            <a:prstGeom prst="rect">
              <a:avLst/>
            </a:prstGeom>
          </p:spPr>
        </p:pic>
        <p:sp>
          <p:nvSpPr>
            <p:cNvPr id="8" name="Rectangle 46"/>
            <p:cNvSpPr>
              <a:spLocks noChangeArrowheads="1"/>
            </p:cNvSpPr>
            <p:nvPr/>
          </p:nvSpPr>
          <p:spPr bwMode="auto">
            <a:xfrm>
              <a:off x="2195629" y="1381568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3</a:t>
              </a:r>
              <a:endParaRPr kumimoji="0" lang="fr-FR" altLang="fr-FR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9" name="Rectangle 46"/>
            <p:cNvSpPr>
              <a:spLocks noChangeArrowheads="1"/>
            </p:cNvSpPr>
            <p:nvPr/>
          </p:nvSpPr>
          <p:spPr bwMode="auto">
            <a:xfrm>
              <a:off x="2072198" y="2032490"/>
              <a:ext cx="38792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0 033</a:t>
              </a:r>
              <a:endParaRPr kumimoji="0" lang="fr-FR" altLang="fr-FR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" name="Rectangle 46"/>
            <p:cNvSpPr>
              <a:spLocks noChangeArrowheads="1"/>
            </p:cNvSpPr>
            <p:nvPr/>
          </p:nvSpPr>
          <p:spPr bwMode="auto">
            <a:xfrm>
              <a:off x="2230895" y="2683413"/>
              <a:ext cx="7053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fr-FR" altLang="fr-FR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11" name="Group 10"/>
          <p:cNvGrpSpPr/>
          <p:nvPr/>
        </p:nvGrpSpPr>
        <p:grpSpPr>
          <a:xfrm>
            <a:off x="3019990" y="661846"/>
            <a:ext cx="1414456" cy="2377869"/>
            <a:chOff x="1562138" y="799171"/>
            <a:chExt cx="1414456" cy="2377869"/>
          </a:xfrm>
        </p:grpSpPr>
        <p:sp>
          <p:nvSpPr>
            <p:cNvPr id="12" name="TextBox 11"/>
            <p:cNvSpPr txBox="1"/>
            <p:nvPr/>
          </p:nvSpPr>
          <p:spPr>
            <a:xfrm>
              <a:off x="1947003" y="799171"/>
              <a:ext cx="6383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/>
                <a:t>lncRNA</a:t>
              </a:r>
              <a:endParaRPr lang="en-GB" sz="1200" dirty="0"/>
            </a:p>
          </p:txBody>
        </p:sp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1215196" y="1415642"/>
              <a:ext cx="2108340" cy="1414456"/>
            </a:xfrm>
            <a:prstGeom prst="rect">
              <a:avLst/>
            </a:prstGeom>
          </p:spPr>
        </p:pic>
        <p:sp>
          <p:nvSpPr>
            <p:cNvPr id="14" name="Rectangle 46"/>
            <p:cNvSpPr>
              <a:spLocks noChangeArrowheads="1"/>
            </p:cNvSpPr>
            <p:nvPr/>
          </p:nvSpPr>
          <p:spPr bwMode="auto">
            <a:xfrm>
              <a:off x="2160363" y="1381568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62</a:t>
              </a:r>
              <a:endParaRPr kumimoji="0" lang="fr-FR" altLang="fr-FR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" name="Rectangle 46"/>
            <p:cNvSpPr>
              <a:spLocks noChangeArrowheads="1"/>
            </p:cNvSpPr>
            <p:nvPr/>
          </p:nvSpPr>
          <p:spPr bwMode="auto">
            <a:xfrm>
              <a:off x="2107465" y="2032490"/>
              <a:ext cx="3173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 855</a:t>
              </a:r>
              <a:endParaRPr kumimoji="0" lang="fr-FR" altLang="fr-FR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6" name="Rectangle 46"/>
            <p:cNvSpPr>
              <a:spLocks noChangeArrowheads="1"/>
            </p:cNvSpPr>
            <p:nvPr/>
          </p:nvSpPr>
          <p:spPr bwMode="auto">
            <a:xfrm>
              <a:off x="2230895" y="2683413"/>
              <a:ext cx="7053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fr-FR" altLang="fr-FR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17" name="Rectangle 16"/>
          <p:cNvSpPr/>
          <p:nvPr/>
        </p:nvSpPr>
        <p:spPr>
          <a:xfrm>
            <a:off x="2800220" y="530651"/>
            <a:ext cx="2936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864922" y="530651"/>
            <a:ext cx="28405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6200000">
            <a:off x="703994" y="4164864"/>
            <a:ext cx="647614" cy="184666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12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NA-seq</a:t>
            </a:r>
          </a:p>
        </p:txBody>
      </p:sp>
      <p:sp>
        <p:nvSpPr>
          <p:cNvPr id="27" name="TextBox 26"/>
          <p:cNvSpPr txBox="1"/>
          <p:nvPr/>
        </p:nvSpPr>
        <p:spPr>
          <a:xfrm rot="16200000">
            <a:off x="875611" y="5078600"/>
            <a:ext cx="304379" cy="184666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1200" b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TA</a:t>
            </a:r>
          </a:p>
        </p:txBody>
      </p:sp>
      <p:grpSp>
        <p:nvGrpSpPr>
          <p:cNvPr id="28" name="Group 27"/>
          <p:cNvGrpSpPr/>
          <p:nvPr/>
        </p:nvGrpSpPr>
        <p:grpSpPr>
          <a:xfrm>
            <a:off x="1197352" y="3425167"/>
            <a:ext cx="1519327" cy="2378235"/>
            <a:chOff x="1543815" y="798805"/>
            <a:chExt cx="1519327" cy="2378235"/>
          </a:xfrm>
        </p:grpSpPr>
        <p:sp>
          <p:nvSpPr>
            <p:cNvPr id="29" name="TextBox 28"/>
            <p:cNvSpPr txBox="1"/>
            <p:nvPr/>
          </p:nvSpPr>
          <p:spPr>
            <a:xfrm>
              <a:off x="1543815" y="798805"/>
              <a:ext cx="15193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/>
                <a:t>protein coding mRNA</a:t>
              </a:r>
              <a:endParaRPr lang="en-GB" sz="1200" dirty="0"/>
            </a:p>
          </p:txBody>
        </p:sp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1215196" y="1415642"/>
              <a:ext cx="2108340" cy="1414456"/>
            </a:xfrm>
            <a:prstGeom prst="rect">
              <a:avLst/>
            </a:prstGeom>
          </p:spPr>
        </p:pic>
        <p:sp>
          <p:nvSpPr>
            <p:cNvPr id="31" name="Rectangle 46"/>
            <p:cNvSpPr>
              <a:spLocks noChangeArrowheads="1"/>
            </p:cNvSpPr>
            <p:nvPr/>
          </p:nvSpPr>
          <p:spPr bwMode="auto">
            <a:xfrm>
              <a:off x="2072199" y="1381568"/>
              <a:ext cx="38792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7 358</a:t>
              </a:r>
              <a:endParaRPr kumimoji="0" lang="fr-FR" altLang="fr-FR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2" name="Rectangle 46"/>
            <p:cNvSpPr>
              <a:spLocks noChangeArrowheads="1"/>
            </p:cNvSpPr>
            <p:nvPr/>
          </p:nvSpPr>
          <p:spPr bwMode="auto">
            <a:xfrm>
              <a:off x="2036932" y="2032490"/>
              <a:ext cx="4584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11 866</a:t>
              </a:r>
              <a:endParaRPr kumimoji="0" lang="fr-FR" altLang="fr-FR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3" name="Rectangle 46"/>
            <p:cNvSpPr>
              <a:spLocks noChangeArrowheads="1"/>
            </p:cNvSpPr>
            <p:nvPr/>
          </p:nvSpPr>
          <p:spPr bwMode="auto">
            <a:xfrm>
              <a:off x="2230895" y="2683413"/>
              <a:ext cx="7053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fr-FR" altLang="fr-FR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34" name="Group 33"/>
          <p:cNvGrpSpPr/>
          <p:nvPr/>
        </p:nvGrpSpPr>
        <p:grpSpPr>
          <a:xfrm>
            <a:off x="3019990" y="3425167"/>
            <a:ext cx="1414456" cy="2377869"/>
            <a:chOff x="1562138" y="799171"/>
            <a:chExt cx="1414456" cy="2377869"/>
          </a:xfrm>
        </p:grpSpPr>
        <p:sp>
          <p:nvSpPr>
            <p:cNvPr id="35" name="TextBox 34"/>
            <p:cNvSpPr txBox="1"/>
            <p:nvPr/>
          </p:nvSpPr>
          <p:spPr>
            <a:xfrm>
              <a:off x="1947003" y="799171"/>
              <a:ext cx="6383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/>
                <a:t>lncRNA</a:t>
              </a:r>
              <a:endParaRPr lang="en-GB" sz="1200" dirty="0"/>
            </a:p>
          </p:txBody>
        </p:sp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1215196" y="1415642"/>
              <a:ext cx="2108340" cy="1414456"/>
            </a:xfrm>
            <a:prstGeom prst="rect">
              <a:avLst/>
            </a:prstGeom>
          </p:spPr>
        </p:pic>
        <p:sp>
          <p:nvSpPr>
            <p:cNvPr id="37" name="Rectangle 46"/>
            <p:cNvSpPr>
              <a:spLocks noChangeArrowheads="1"/>
            </p:cNvSpPr>
            <p:nvPr/>
          </p:nvSpPr>
          <p:spPr bwMode="auto">
            <a:xfrm>
              <a:off x="2107464" y="1381568"/>
              <a:ext cx="317395" cy="153888"/>
            </a:xfrm>
            <a:prstGeom prst="rect">
              <a:avLst/>
            </a:pr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algn="ctr"/>
              <a:r>
                <a:rPr lang="fr-FR" altLang="fr-FR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2 875</a:t>
              </a:r>
              <a:endParaRPr kumimoji="0" lang="fr-FR" altLang="fr-FR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8" name="Rectangle 46"/>
            <p:cNvSpPr>
              <a:spLocks noChangeArrowheads="1"/>
            </p:cNvSpPr>
            <p:nvPr/>
          </p:nvSpPr>
          <p:spPr bwMode="auto">
            <a:xfrm>
              <a:off x="2072201" y="2032490"/>
              <a:ext cx="387927" cy="153888"/>
            </a:xfrm>
            <a:prstGeom prst="rect">
              <a:avLst/>
            </a:pr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algn="ctr"/>
              <a:r>
                <a:rPr lang="fr-FR" altLang="fr-FR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25 640</a:t>
              </a:r>
              <a:endParaRPr kumimoji="0" lang="fr-FR" altLang="fr-FR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9" name="Rectangle 46"/>
            <p:cNvSpPr>
              <a:spLocks noChangeArrowheads="1"/>
            </p:cNvSpPr>
            <p:nvPr/>
          </p:nvSpPr>
          <p:spPr bwMode="auto">
            <a:xfrm>
              <a:off x="2230895" y="2683413"/>
              <a:ext cx="7053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fr-FR" altLang="fr-FR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40" name="Rectangle 39"/>
          <p:cNvSpPr/>
          <p:nvPr/>
        </p:nvSpPr>
        <p:spPr>
          <a:xfrm>
            <a:off x="2800220" y="3293972"/>
            <a:ext cx="2936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Rectangle 47"/>
          <p:cNvSpPr/>
          <p:nvPr/>
        </p:nvSpPr>
        <p:spPr>
          <a:xfrm>
            <a:off x="864922" y="3293972"/>
            <a:ext cx="28405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 rot="16200000">
            <a:off x="313268" y="1718733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enes</a:t>
            </a:r>
          </a:p>
        </p:txBody>
      </p:sp>
      <p:sp>
        <p:nvSpPr>
          <p:cNvPr id="41" name="TextBox 40"/>
          <p:cNvSpPr txBox="1"/>
          <p:nvPr/>
        </p:nvSpPr>
        <p:spPr>
          <a:xfrm rot="16200000">
            <a:off x="372533" y="4555069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ons</a:t>
            </a:r>
          </a:p>
        </p:txBody>
      </p:sp>
    </p:spTree>
    <p:extLst>
      <p:ext uri="{BB962C8B-B14F-4D97-AF65-F5344CB8AC3E}">
        <p14:creationId xmlns:p14="http://schemas.microsoft.com/office/powerpoint/2010/main" val="11817339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7120" y="369013"/>
            <a:ext cx="4724400" cy="35433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 rot="16200000">
            <a:off x="416133" y="1098333"/>
            <a:ext cx="10518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Normal tissue</a:t>
            </a:r>
            <a:endParaRPr lang="en-GB" sz="1200" dirty="0"/>
          </a:p>
        </p:txBody>
      </p:sp>
      <p:sp>
        <p:nvSpPr>
          <p:cNvPr id="6" name="TextBox 5"/>
          <p:cNvSpPr txBox="1"/>
          <p:nvPr/>
        </p:nvSpPr>
        <p:spPr>
          <a:xfrm rot="16200000">
            <a:off x="407283" y="2900174"/>
            <a:ext cx="10695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Tumour</a:t>
            </a:r>
            <a:r>
              <a:rPr lang="en-US" sz="1200" dirty="0"/>
              <a:t> tissue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637283" y="336367"/>
            <a:ext cx="641522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000" b="1" dirty="0"/>
              <a:t>RNA-seq</a:t>
            </a:r>
            <a:endParaRPr lang="en-GB" sz="10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3200784" y="327941"/>
            <a:ext cx="609601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HTA</a:t>
            </a:r>
            <a:endParaRPr lang="en-GB" sz="10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1625091" y="2140102"/>
            <a:ext cx="641522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000" b="1" dirty="0"/>
              <a:t>RNA-seq</a:t>
            </a:r>
            <a:endParaRPr lang="en-GB" sz="10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3200784" y="2147177"/>
            <a:ext cx="609601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HTA</a:t>
            </a:r>
            <a:endParaRPr lang="en-GB" sz="10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467360" y="4325742"/>
            <a:ext cx="605536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4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Dependency of the standard deviation of gene expression between biological replicates on the mean signal level for normal (top row: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-c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and tumour (bottom row: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-f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groups. Lines show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Lowess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smoothing. In the right most plots (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comparison of the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Lowess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regression lines is given for scaled gene expression. Variability between biological replicates is higher for RNA-seq data for both normal and tumour samples, especially for low abundant transcripts.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434840" y="336367"/>
            <a:ext cx="1388154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Comparison</a:t>
            </a:r>
            <a:endParaRPr lang="en-GB" sz="10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4416315" y="2140101"/>
            <a:ext cx="1388154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Comparison</a:t>
            </a:r>
            <a:endParaRPr lang="en-GB" sz="1000" b="1" dirty="0"/>
          </a:p>
        </p:txBody>
      </p:sp>
      <p:sp>
        <p:nvSpPr>
          <p:cNvPr id="16" name="Rectangle 15"/>
          <p:cNvSpPr/>
          <p:nvPr/>
        </p:nvSpPr>
        <p:spPr>
          <a:xfrm>
            <a:off x="1036458" y="327942"/>
            <a:ext cx="28405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2612151" y="327941"/>
            <a:ext cx="2936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4263161" y="327941"/>
            <a:ext cx="28405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960258" y="2137632"/>
            <a:ext cx="2936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2535951" y="2137631"/>
            <a:ext cx="28405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4186961" y="2137631"/>
            <a:ext cx="2439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496086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6797" y="323385"/>
            <a:ext cx="5707681" cy="5705994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1349298" y="3300760"/>
            <a:ext cx="1483112" cy="32338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" name="Rectangle 3"/>
          <p:cNvSpPr/>
          <p:nvPr/>
        </p:nvSpPr>
        <p:spPr>
          <a:xfrm>
            <a:off x="1349298" y="431180"/>
            <a:ext cx="1483112" cy="32338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Rectangle 4"/>
          <p:cNvSpPr/>
          <p:nvPr/>
        </p:nvSpPr>
        <p:spPr>
          <a:xfrm>
            <a:off x="4155688" y="3300759"/>
            <a:ext cx="1483112" cy="32338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Rectangle 5"/>
          <p:cNvSpPr/>
          <p:nvPr/>
        </p:nvSpPr>
        <p:spPr>
          <a:xfrm>
            <a:off x="4155688" y="431180"/>
            <a:ext cx="1483112" cy="32338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TextBox 6"/>
          <p:cNvSpPr txBox="1"/>
          <p:nvPr/>
        </p:nvSpPr>
        <p:spPr>
          <a:xfrm>
            <a:off x="658925" y="47578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644911" y="475784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56257" y="330075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644911" y="3300759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47717" y="6137174"/>
            <a:ext cx="608584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5.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Dynamic range for RNA-seq (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and HTA (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platforms based on significantly differentially expressed genes (FDR&lt;0.01). (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and (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show the distribution of expressions (averaged over all samples) for all genes and significant genes only, with the same cut-off used to determine the dynamic range. The distributions of log</a:t>
            </a:r>
            <a:r>
              <a:rPr lang="en-GB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FC are presented in (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and (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222502" y="2188210"/>
            <a:ext cx="10987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dynamic range</a:t>
            </a:r>
            <a:endParaRPr lang="en-GB" sz="1200" dirty="0"/>
          </a:p>
        </p:txBody>
      </p:sp>
      <p:cxnSp>
        <p:nvCxnSpPr>
          <p:cNvPr id="14" name="Straight Arrow Connector 13"/>
          <p:cNvCxnSpPr/>
          <p:nvPr/>
        </p:nvCxnSpPr>
        <p:spPr>
          <a:xfrm flipV="1">
            <a:off x="1237742" y="2432126"/>
            <a:ext cx="1196848" cy="3226"/>
          </a:xfrm>
          <a:prstGeom prst="straightConnector1">
            <a:avLst/>
          </a:prstGeom>
          <a:ln>
            <a:solidFill>
              <a:schemeClr val="tx1"/>
            </a:solidFill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1384562" y="4848860"/>
            <a:ext cx="7120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dynamic</a:t>
            </a:r>
          </a:p>
          <a:p>
            <a:pPr algn="ctr"/>
            <a:r>
              <a:rPr lang="en-US" sz="1200" dirty="0"/>
              <a:t> range</a:t>
            </a:r>
            <a:endParaRPr lang="en-GB" sz="1200" dirty="0"/>
          </a:p>
        </p:txBody>
      </p:sp>
      <p:cxnSp>
        <p:nvCxnSpPr>
          <p:cNvPr id="18" name="Straight Arrow Connector 17"/>
          <p:cNvCxnSpPr/>
          <p:nvPr/>
        </p:nvCxnSpPr>
        <p:spPr>
          <a:xfrm flipV="1">
            <a:off x="1384562" y="5280660"/>
            <a:ext cx="863338" cy="762"/>
          </a:xfrm>
          <a:prstGeom prst="straightConnector1">
            <a:avLst/>
          </a:prstGeom>
          <a:ln>
            <a:solidFill>
              <a:schemeClr val="tx1"/>
            </a:solidFill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2237923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248863" y="4842269"/>
            <a:ext cx="608584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6.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MA-plots representing populations of all (grey) and significant (coloured) coding mRNAs (top panel: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lncRNAs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(bottom panel: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assessed by RNA-seq (left panel, red and orange in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and HTA platforms (right panel, blue and cyan in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. Shaded areas in the figures of the top-most panel (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correspond to the detection limits. 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77891"/>
            <a:ext cx="6858000" cy="411421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36880" y="477890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144948" y="477890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36880" y="133712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144948" y="1337126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187868" y="1337125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36880" y="2964618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144948" y="2964617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6187868" y="2964616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4589365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866601" y="149093"/>
            <a:ext cx="1511593" cy="280076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NA-</a:t>
            </a:r>
            <a:r>
              <a:rPr lang="en-US" sz="1000" b="1" dirty="0" err="1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0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nly</a:t>
            </a:r>
            <a:endParaRPr lang="en-US"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buFont typeface="Arial" panose="020B0604020202020204" pitchFamily="34" charset="0"/>
              <a:buChar char="•"/>
            </a:pP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issue development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evelopmental process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extracellular matrix organizatio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extracellular structure organizatio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ingle-organism cellular process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ingle-organism process	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ollagen catabolic process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raciliary</a:t>
            </a: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ransport	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ell proliferation	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ulticellular organismal process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GB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negative regulation of cell-substrate adhesio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GB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ositive regulation of mitotic cell cycle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ell-substrate junction assembly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regulation of cell proliferatio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reproduction	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response to alcohol	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DP phosphorylation	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locomotion	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glucose catabolic process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ell junction organizatio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yruvate metabolic process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ensory organ morphogenesis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moothened signaling pathway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gative regulation of biological process</a:t>
            </a:r>
          </a:p>
        </p:txBody>
      </p:sp>
      <p:sp>
        <p:nvSpPr>
          <p:cNvPr id="3" name="Rectangle 2"/>
          <p:cNvSpPr/>
          <p:nvPr/>
        </p:nvSpPr>
        <p:spPr>
          <a:xfrm>
            <a:off x="3281544" y="149093"/>
            <a:ext cx="2044700" cy="36317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mon</a:t>
            </a:r>
            <a:endParaRPr lang="en-US" sz="1000" b="1" dirty="0">
              <a:solidFill>
                <a:srgbClr val="9933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buFont typeface="Arial" panose="020B0604020202020204" pitchFamily="34" charset="0"/>
              <a:buChar char="•"/>
            </a:pP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icrotubule-based process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itotic cell cycle process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icrotubule cytoskeleton organizatio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ell cycle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GB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ellular component organization or biogenesis</a:t>
            </a:r>
            <a:r>
              <a:rPr lang="en-GB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ell division 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xonemal dynein complex assembly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NA-dependent DNA replication 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hromosome segregatio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NA strand elongatio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GB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atomical structure formation involved in morphogenesis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GB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aphase-promoting complex-dependent </a:t>
            </a:r>
            <a:r>
              <a:rPr lang="en-GB" sz="6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teasomal</a:t>
            </a:r>
            <a:r>
              <a:rPr lang="en-GB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ubiquitin- dependent protein catabolic process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NA metabolic process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ellular response to DNA damage stimulus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ellular component movement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regulation of chromosome segregatio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regulation of cell divisio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GB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regulation of ubiquitin-protein transferase activity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GB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ilium or flagellum-dependent cell motility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nucleoside diphosphate phosphorylatio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atomical structure homeostasis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nucleotide phosphorylatio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NADH regeneratio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glycolytic process through fructose-6-phosphate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anonical glycolysis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nucleoside diphosphate metabolic process</a:t>
            </a:r>
          </a:p>
        </p:txBody>
      </p:sp>
      <p:sp>
        <p:nvSpPr>
          <p:cNvPr id="4" name="Rectangle 3"/>
          <p:cNvSpPr/>
          <p:nvPr/>
        </p:nvSpPr>
        <p:spPr>
          <a:xfrm>
            <a:off x="5162380" y="149093"/>
            <a:ext cx="1615110" cy="24622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TA only</a:t>
            </a:r>
            <a:endParaRPr lang="en-US" sz="1000" b="1" dirty="0">
              <a:solidFill>
                <a:srgbClr val="0033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rotein-DNA complex assembly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GB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nuclear cell cycle DNA replicatio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GB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mall </a:t>
            </a:r>
            <a:r>
              <a:rPr lang="en-GB" sz="6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TPase</a:t>
            </a:r>
            <a:r>
              <a:rPr lang="en-GB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ediated signal transductio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GB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negative regulation of ubiquitin-protein  transferase activity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itotic recombinatio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hromosome localizatio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GB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epithelial cilium movement involved in  determination of left/right asymmetry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NA duplex unwinding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teasomal</a:t>
            </a: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rotein catabolic process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GB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negative regulation of chromosome segregatio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rotein localization to chromosome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streplication</a:t>
            </a: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repair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GB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ositive regulation of canonical </a:t>
            </a:r>
            <a:r>
              <a:rPr lang="en-GB" sz="6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t</a:t>
            </a:r>
            <a:r>
              <a:rPr lang="en-GB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6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gnaling</a:t>
            </a:r>
            <a:r>
              <a:rPr lang="en-GB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athway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guanosine-containing compound biosynthetic process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nslesion</a:t>
            </a: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ynthesis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GB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tigen processing and presentation of peptide antige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ingle-organism metabolic process</a:t>
            </a:r>
          </a:p>
        </p:txBody>
      </p:sp>
      <p:sp>
        <p:nvSpPr>
          <p:cNvPr id="6" name="Rectangle 5"/>
          <p:cNvSpPr/>
          <p:nvPr/>
        </p:nvSpPr>
        <p:spPr>
          <a:xfrm>
            <a:off x="1866601" y="3812881"/>
            <a:ext cx="1499556" cy="8002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NA-</a:t>
            </a:r>
            <a:r>
              <a:rPr lang="en-US" sz="1000" b="1" dirty="0" err="1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0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nly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extracellular matrix structural constituent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tructural molecule activity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GB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rotein binding involved in cell adhesio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rotein complex binding</a:t>
            </a:r>
          </a:p>
        </p:txBody>
      </p:sp>
      <p:sp>
        <p:nvSpPr>
          <p:cNvPr id="7" name="Rectangle 6"/>
          <p:cNvSpPr/>
          <p:nvPr/>
        </p:nvSpPr>
        <p:spPr>
          <a:xfrm>
            <a:off x="3274209" y="3817552"/>
            <a:ext cx="1648311" cy="8002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mon</a:t>
            </a:r>
            <a:endParaRPr lang="en-US" sz="800" b="1" dirty="0">
              <a:solidFill>
                <a:srgbClr val="9933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icrotubule motor activity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ubulin binding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rotein binding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otor activity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TP binding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arbohydrate derivative binding</a:t>
            </a:r>
          </a:p>
        </p:txBody>
      </p:sp>
      <p:sp>
        <p:nvSpPr>
          <p:cNvPr id="8" name="Rectangle 7"/>
          <p:cNvSpPr/>
          <p:nvPr/>
        </p:nvSpPr>
        <p:spPr>
          <a:xfrm>
            <a:off x="5155045" y="3809874"/>
            <a:ext cx="1640561" cy="135421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TA only</a:t>
            </a:r>
            <a:endParaRPr lang="en-US" sz="800" b="1" dirty="0">
              <a:solidFill>
                <a:srgbClr val="0033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urine ribonucleotide binding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nucleoside phosphate binding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mall molecule binding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binding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heterocyclic compound binding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rganic cyclic compound binding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NA-dependent ATPase activity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oly(A) RNA binding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tructure-specific DNA binding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histone binding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RNA binding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amaged DNA binding</a:t>
            </a:r>
          </a:p>
        </p:txBody>
      </p:sp>
      <p:sp>
        <p:nvSpPr>
          <p:cNvPr id="10" name="Rectangle 9"/>
          <p:cNvSpPr/>
          <p:nvPr/>
        </p:nvSpPr>
        <p:spPr>
          <a:xfrm>
            <a:off x="1853060" y="5182175"/>
            <a:ext cx="1428484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NA-</a:t>
            </a:r>
            <a:r>
              <a:rPr lang="en-US" sz="1000" b="1" dirty="0" err="1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0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nly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extracellular region</a:t>
            </a:r>
            <a:endParaRPr lang="en-US" sz="9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roteinaceous extracellular matrix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extracellular matrix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raciliary</a:t>
            </a: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ransport particle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rimary cilium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ell-cell junctio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ollagen trimer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haperonin-containing T-complex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raciliary</a:t>
            </a: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ransport particle B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itotic spindle </a:t>
            </a:r>
            <a:r>
              <a:rPr lang="en-US" sz="6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dzone</a:t>
            </a:r>
            <a:endParaRPr lang="en-US" sz="6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ell junctio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embrane regio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U4 </a:t>
            </a:r>
            <a:r>
              <a:rPr lang="en-US" sz="6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nRNP</a:t>
            </a:r>
            <a:endParaRPr lang="en-US" sz="6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lasma membrane region</a:t>
            </a:r>
          </a:p>
        </p:txBody>
      </p:sp>
      <p:sp>
        <p:nvSpPr>
          <p:cNvPr id="11" name="Rectangle 10"/>
          <p:cNvSpPr/>
          <p:nvPr/>
        </p:nvSpPr>
        <p:spPr>
          <a:xfrm>
            <a:off x="3295819" y="5182175"/>
            <a:ext cx="1661879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mon</a:t>
            </a:r>
            <a:endParaRPr lang="en-US" sz="1200" b="1" dirty="0">
              <a:solidFill>
                <a:srgbClr val="9933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buFont typeface="Arial" panose="020B0604020202020204" pitchFamily="34" charset="0"/>
              <a:buChar char="•"/>
            </a:pP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icrotubule cytoskeleto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ilium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non-membrane-bounded organelle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rganelle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rotein complex</a:t>
            </a:r>
            <a:endParaRPr lang="en-US" sz="9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ytoplasm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ell projectio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acromolecular complex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extracellular region part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dbody</a:t>
            </a:r>
            <a:endParaRPr lang="en-US" sz="6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banded collagen fibril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vesicle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omplex of collagen trimers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ytoplasmic part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ytosol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CM complex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roteasome accessory complex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esmosome</a:t>
            </a:r>
          </a:p>
        </p:txBody>
      </p:sp>
      <p:sp>
        <p:nvSpPr>
          <p:cNvPr id="12" name="Rectangle 11"/>
          <p:cNvSpPr/>
          <p:nvPr/>
        </p:nvSpPr>
        <p:spPr>
          <a:xfrm>
            <a:off x="5155045" y="5182175"/>
            <a:ext cx="1473943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TA only</a:t>
            </a:r>
            <a:endParaRPr lang="en-US" sz="1000" b="1" dirty="0">
              <a:solidFill>
                <a:srgbClr val="0033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buFont typeface="Arial" panose="020B0604020202020204" pitchFamily="34" charset="0"/>
              <a:buChar char="•"/>
            </a:pP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nuclear part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embrane-enclosed lume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tracellular part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tracellular</a:t>
            </a:r>
            <a:endParaRPr lang="en-US" sz="9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NA packaging complex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rotein-DNA complex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roteasome complex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ell part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ell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envelope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NA polymerase complex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ytosolic proteasome complex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icrotubule organizing center part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853060" y="6986235"/>
            <a:ext cx="1113411" cy="46166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FDR)&gt; 18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lang="en-US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FDR)&gt; 10</a:t>
            </a:r>
          </a:p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lang="en-US" sz="6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(FDR)&gt; 2</a:t>
            </a:r>
          </a:p>
        </p:txBody>
      </p:sp>
      <p:sp>
        <p:nvSpPr>
          <p:cNvPr id="14" name="Rectangle 13"/>
          <p:cNvSpPr/>
          <p:nvPr/>
        </p:nvSpPr>
        <p:spPr>
          <a:xfrm>
            <a:off x="284962" y="7840017"/>
            <a:ext cx="6344026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7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nriched gene ontology biological processes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, molecular functions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and cellular components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by significant (FDR&lt;10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-4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protein coding genes from unpaired RNA-seq (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edg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and HTA (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limm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analyses. Only ontology terms with FDR &lt; 0.01 were considered and compressed into short lists by REVIGO semantic analysis. The order and font size represent the FDR-based score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he most significant/represented are at the top of the list and with larger font.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Group 20"/>
          <p:cNvGrpSpPr/>
          <p:nvPr/>
        </p:nvGrpSpPr>
        <p:grpSpPr>
          <a:xfrm>
            <a:off x="238560" y="90162"/>
            <a:ext cx="1715530" cy="1818262"/>
            <a:chOff x="330059" y="435991"/>
            <a:chExt cx="2450755" cy="2597518"/>
          </a:xfrm>
        </p:grpSpPr>
        <p:sp>
          <p:nvSpPr>
            <p:cNvPr id="22" name="TextBox 21"/>
            <p:cNvSpPr txBox="1"/>
            <p:nvPr/>
          </p:nvSpPr>
          <p:spPr>
            <a:xfrm>
              <a:off x="695813" y="513032"/>
              <a:ext cx="2085001" cy="3957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/>
                <a:t>Biological processes</a:t>
              </a:r>
              <a:endParaRPr lang="en-GB" sz="1200" b="1" dirty="0"/>
            </a:p>
          </p:txBody>
        </p:sp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649283" y="1272111"/>
              <a:ext cx="2108340" cy="1414455"/>
            </a:xfrm>
            <a:prstGeom prst="rect">
              <a:avLst/>
            </a:prstGeom>
          </p:spPr>
        </p:pic>
        <p:sp>
          <p:nvSpPr>
            <p:cNvPr id="24" name="Rectangle 46"/>
            <p:cNvSpPr>
              <a:spLocks noChangeArrowheads="1"/>
            </p:cNvSpPr>
            <p:nvPr/>
          </p:nvSpPr>
          <p:spPr bwMode="auto">
            <a:xfrm>
              <a:off x="1597658" y="1242466"/>
              <a:ext cx="211596" cy="1538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algn="ctr"/>
              <a:r>
                <a:rPr lang="fr-FR" altLang="fr-FR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114</a:t>
              </a:r>
              <a:endParaRPr kumimoji="0" lang="fr-FR" altLang="fr-FR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" name="Rectangle 46"/>
            <p:cNvSpPr>
              <a:spLocks noChangeArrowheads="1"/>
            </p:cNvSpPr>
            <p:nvPr/>
          </p:nvSpPr>
          <p:spPr bwMode="auto">
            <a:xfrm>
              <a:off x="1597658" y="1889768"/>
              <a:ext cx="211596" cy="1538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14</a:t>
              </a:r>
            </a:p>
          </p:txBody>
        </p:sp>
        <p:sp>
          <p:nvSpPr>
            <p:cNvPr id="26" name="Rectangle 25"/>
            <p:cNvSpPr>
              <a:spLocks noChangeArrowheads="1"/>
            </p:cNvSpPr>
            <p:nvPr/>
          </p:nvSpPr>
          <p:spPr bwMode="auto">
            <a:xfrm>
              <a:off x="1597658" y="2544310"/>
              <a:ext cx="211596" cy="1538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algn="ctr"/>
              <a:r>
                <a:rPr lang="fr-FR" altLang="fr-FR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127</a:t>
              </a:r>
              <a:endParaRPr kumimoji="0" lang="fr-FR" altLang="fr-FR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7" name="Rectangle 26"/>
            <p:cNvSpPr/>
            <p:nvPr/>
          </p:nvSpPr>
          <p:spPr>
            <a:xfrm>
              <a:off x="330059" y="435991"/>
              <a:ext cx="314671" cy="43968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 rot="16200000">
              <a:off x="490091" y="1466386"/>
              <a:ext cx="774023" cy="21984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NA-</a:t>
              </a:r>
              <a:r>
                <a:rPr lang="en-US" sz="1000" b="1" dirty="0" err="1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q</a:t>
              </a:r>
              <a:endParaRPr lang="en-US" sz="9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 rot="16200000">
              <a:off x="744855" y="2315236"/>
              <a:ext cx="264496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TA</a:t>
              </a:r>
              <a:endParaRPr lang="en-US" sz="9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9" name="Group 38"/>
          <p:cNvGrpSpPr/>
          <p:nvPr/>
        </p:nvGrpSpPr>
        <p:grpSpPr>
          <a:xfrm>
            <a:off x="228400" y="3112677"/>
            <a:ext cx="1702176" cy="1845101"/>
            <a:chOff x="354544" y="397651"/>
            <a:chExt cx="2431678" cy="2635858"/>
          </a:xfrm>
        </p:grpSpPr>
        <p:sp>
          <p:nvSpPr>
            <p:cNvPr id="40" name="TextBox 39"/>
            <p:cNvSpPr txBox="1"/>
            <p:nvPr/>
          </p:nvSpPr>
          <p:spPr>
            <a:xfrm>
              <a:off x="690411" y="513032"/>
              <a:ext cx="2095811" cy="3957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/>
                <a:t>Molecular functions</a:t>
              </a:r>
              <a:endParaRPr lang="en-GB" sz="1200" b="1" dirty="0"/>
            </a:p>
          </p:txBody>
        </p:sp>
        <p:pic>
          <p:nvPicPr>
            <p:cNvPr id="41" name="Picture 40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649283" y="1272111"/>
              <a:ext cx="2108340" cy="1414455"/>
            </a:xfrm>
            <a:prstGeom prst="rect">
              <a:avLst/>
            </a:prstGeom>
          </p:spPr>
        </p:pic>
        <p:sp>
          <p:nvSpPr>
            <p:cNvPr id="42" name="Rectangle 46"/>
            <p:cNvSpPr>
              <a:spLocks noChangeArrowheads="1"/>
            </p:cNvSpPr>
            <p:nvPr/>
          </p:nvSpPr>
          <p:spPr bwMode="auto">
            <a:xfrm>
              <a:off x="1653074" y="1253352"/>
              <a:ext cx="100760" cy="2198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algn="ctr"/>
              <a:r>
                <a:rPr lang="fr-FR" altLang="fr-FR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5</a:t>
              </a:r>
              <a:endParaRPr kumimoji="0" lang="fr-FR" altLang="fr-FR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3" name="Rectangle 46"/>
            <p:cNvSpPr>
              <a:spLocks noChangeArrowheads="1"/>
            </p:cNvSpPr>
            <p:nvPr/>
          </p:nvSpPr>
          <p:spPr bwMode="auto">
            <a:xfrm>
              <a:off x="1602694" y="1900653"/>
              <a:ext cx="201520" cy="2198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4</a:t>
              </a:r>
            </a:p>
          </p:txBody>
        </p:sp>
        <p:sp>
          <p:nvSpPr>
            <p:cNvPr id="44" name="Rectangle 43"/>
            <p:cNvSpPr>
              <a:spLocks noChangeArrowheads="1"/>
            </p:cNvSpPr>
            <p:nvPr/>
          </p:nvSpPr>
          <p:spPr bwMode="auto">
            <a:xfrm>
              <a:off x="1602694" y="2555196"/>
              <a:ext cx="201520" cy="2198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algn="ctr"/>
              <a:r>
                <a:rPr lang="fr-FR" altLang="fr-FR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23</a:t>
              </a:r>
              <a:endParaRPr kumimoji="0" lang="fr-FR" altLang="fr-FR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5" name="Rectangle 44"/>
            <p:cNvSpPr/>
            <p:nvPr/>
          </p:nvSpPr>
          <p:spPr>
            <a:xfrm>
              <a:off x="354544" y="397651"/>
              <a:ext cx="314671" cy="43968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 rot="16200000">
              <a:off x="490091" y="1466386"/>
              <a:ext cx="774023" cy="21984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NA-</a:t>
              </a:r>
              <a:r>
                <a:rPr lang="en-US" sz="1000" b="1" dirty="0" err="1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q</a:t>
              </a:r>
              <a:endParaRPr lang="en-US" sz="9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 rot="16200000">
              <a:off x="744855" y="2315236"/>
              <a:ext cx="264496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TA</a:t>
              </a:r>
              <a:endParaRPr lang="en-US" sz="9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8" name="Group 47"/>
          <p:cNvGrpSpPr/>
          <p:nvPr/>
        </p:nvGrpSpPr>
        <p:grpSpPr>
          <a:xfrm>
            <a:off x="233077" y="5142708"/>
            <a:ext cx="1690439" cy="1858754"/>
            <a:chOff x="396093" y="378146"/>
            <a:chExt cx="2414912" cy="2655363"/>
          </a:xfrm>
        </p:grpSpPr>
        <p:sp>
          <p:nvSpPr>
            <p:cNvPr id="49" name="TextBox 48"/>
            <p:cNvSpPr txBox="1"/>
            <p:nvPr/>
          </p:nvSpPr>
          <p:spPr>
            <a:xfrm>
              <a:off x="665637" y="513032"/>
              <a:ext cx="2145368" cy="3957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/>
                <a:t>Cellular components</a:t>
              </a:r>
              <a:endParaRPr lang="en-GB" sz="1200" b="1" dirty="0"/>
            </a:p>
          </p:txBody>
        </p:sp>
        <p:pic>
          <p:nvPicPr>
            <p:cNvPr id="50" name="Picture 49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649283" y="1272111"/>
              <a:ext cx="2108340" cy="1414455"/>
            </a:xfrm>
            <a:prstGeom prst="rect">
              <a:avLst/>
            </a:prstGeom>
          </p:spPr>
        </p:pic>
        <p:sp>
          <p:nvSpPr>
            <p:cNvPr id="51" name="Rectangle 46"/>
            <p:cNvSpPr>
              <a:spLocks noChangeArrowheads="1"/>
            </p:cNvSpPr>
            <p:nvPr/>
          </p:nvSpPr>
          <p:spPr bwMode="auto">
            <a:xfrm>
              <a:off x="1602694" y="1253352"/>
              <a:ext cx="201520" cy="2198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algn="ctr"/>
              <a:r>
                <a:rPr lang="fr-FR" altLang="fr-FR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20</a:t>
              </a:r>
              <a:endParaRPr kumimoji="0" lang="fr-FR" altLang="fr-FR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2" name="Rectangle 46"/>
            <p:cNvSpPr>
              <a:spLocks noChangeArrowheads="1"/>
            </p:cNvSpPr>
            <p:nvPr/>
          </p:nvSpPr>
          <p:spPr bwMode="auto">
            <a:xfrm>
              <a:off x="1602694" y="1900653"/>
              <a:ext cx="201520" cy="2198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64</a:t>
              </a:r>
            </a:p>
          </p:txBody>
        </p:sp>
        <p:sp>
          <p:nvSpPr>
            <p:cNvPr id="53" name="Rectangle 52"/>
            <p:cNvSpPr>
              <a:spLocks noChangeArrowheads="1"/>
            </p:cNvSpPr>
            <p:nvPr/>
          </p:nvSpPr>
          <p:spPr bwMode="auto">
            <a:xfrm>
              <a:off x="1602694" y="2524816"/>
              <a:ext cx="201520" cy="2198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algn="ctr"/>
              <a:r>
                <a:rPr lang="fr-FR" altLang="fr-FR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41</a:t>
              </a:r>
              <a:endParaRPr kumimoji="0" lang="fr-FR" altLang="fr-FR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4" name="Rectangle 53"/>
            <p:cNvSpPr/>
            <p:nvPr/>
          </p:nvSpPr>
          <p:spPr>
            <a:xfrm>
              <a:off x="396093" y="378146"/>
              <a:ext cx="314671" cy="43968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 rot="16200000">
              <a:off x="490091" y="1466386"/>
              <a:ext cx="774023" cy="21984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NA-</a:t>
              </a:r>
              <a:r>
                <a:rPr lang="en-US" sz="1000" b="1" dirty="0" err="1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q</a:t>
              </a:r>
              <a:endParaRPr lang="en-US" sz="9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 rot="16200000">
              <a:off x="744855" y="2315236"/>
              <a:ext cx="264496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TA</a:t>
              </a:r>
              <a:endParaRPr lang="en-US" sz="9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2312671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73" t="10759" r="4546" b="8236"/>
          <a:stretch/>
        </p:blipFill>
        <p:spPr>
          <a:xfrm>
            <a:off x="1925104" y="626056"/>
            <a:ext cx="3213428" cy="322517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229612" y="2936295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UC16</a:t>
            </a:r>
            <a:endParaRPr lang="lb-L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695846" y="1977198"/>
            <a:ext cx="5229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ERBB4</a:t>
            </a:r>
            <a:endParaRPr lang="lb-L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008536" y="1652622"/>
            <a:ext cx="4090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AI3</a:t>
            </a:r>
            <a:endParaRPr lang="lb-L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454868" y="1633634"/>
            <a:ext cx="6527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UNX1T1</a:t>
            </a:r>
            <a:endParaRPr lang="lb-L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774473" y="1934281"/>
            <a:ext cx="4635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DR2</a:t>
            </a:r>
            <a:endParaRPr lang="lb-L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3512832" y="1442491"/>
            <a:ext cx="51899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lb-LU" sz="800" dirty="0">
                <a:latin typeface="Arial" panose="020B0604020202020204" pitchFamily="34" charset="0"/>
                <a:cs typeface="Arial" panose="020B0604020202020204" pitchFamily="34" charset="0"/>
              </a:rPr>
              <a:t>FGFR1</a:t>
            </a:r>
            <a:endParaRPr lang="lb-LU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4035520" y="1812228"/>
            <a:ext cx="53893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lb-LU" sz="800" dirty="0">
                <a:latin typeface="Arial" panose="020B0604020202020204" pitchFamily="34" charset="0"/>
              </a:rPr>
              <a:t>FBXW7</a:t>
            </a:r>
            <a:endParaRPr lang="lb-LU" dirty="0"/>
          </a:p>
        </p:txBody>
      </p:sp>
      <p:sp>
        <p:nvSpPr>
          <p:cNvPr id="11" name="Rectangle 10"/>
          <p:cNvSpPr/>
          <p:nvPr/>
        </p:nvSpPr>
        <p:spPr>
          <a:xfrm>
            <a:off x="4360357" y="1641925"/>
            <a:ext cx="50045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lb-LU" sz="800" dirty="0">
                <a:latin typeface="Arial" panose="020B0604020202020204" pitchFamily="34" charset="0"/>
              </a:rPr>
              <a:t>STK11</a:t>
            </a:r>
            <a:endParaRPr lang="lb-LU" dirty="0"/>
          </a:p>
        </p:txBody>
      </p:sp>
      <p:sp>
        <p:nvSpPr>
          <p:cNvPr id="12" name="Rectangle 11"/>
          <p:cNvSpPr/>
          <p:nvPr/>
        </p:nvSpPr>
        <p:spPr>
          <a:xfrm>
            <a:off x="3546393" y="1299449"/>
            <a:ext cx="53340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lb-LU" sz="800" dirty="0">
                <a:latin typeface="Arial" panose="020B0604020202020204" pitchFamily="34" charset="0"/>
              </a:rPr>
              <a:t>GRM8</a:t>
            </a:r>
            <a:endParaRPr lang="lb-LU" dirty="0"/>
          </a:p>
        </p:txBody>
      </p:sp>
      <p:cxnSp>
        <p:nvCxnSpPr>
          <p:cNvPr id="14" name="Straight Connector 13"/>
          <p:cNvCxnSpPr/>
          <p:nvPr/>
        </p:nvCxnSpPr>
        <p:spPr>
          <a:xfrm flipH="1" flipV="1">
            <a:off x="4233633" y="1533677"/>
            <a:ext cx="64209" cy="32379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 flipH="1" flipV="1">
            <a:off x="4327832" y="1496758"/>
            <a:ext cx="166224" cy="19341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 flipH="1" flipV="1">
            <a:off x="3945686" y="1426523"/>
            <a:ext cx="308624" cy="368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Rectangle 23"/>
          <p:cNvSpPr/>
          <p:nvPr/>
        </p:nvSpPr>
        <p:spPr>
          <a:xfrm>
            <a:off x="4456251" y="1498715"/>
            <a:ext cx="67037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lb-LU" sz="800" dirty="0">
                <a:latin typeface="Arial" panose="020B0604020202020204" pitchFamily="34" charset="0"/>
              </a:rPr>
              <a:t>WHSC1L1</a:t>
            </a:r>
            <a:endParaRPr lang="lb-LU" dirty="0"/>
          </a:p>
        </p:txBody>
      </p:sp>
      <p:cxnSp>
        <p:nvCxnSpPr>
          <p:cNvPr id="25" name="Straight Connector 24"/>
          <p:cNvCxnSpPr/>
          <p:nvPr/>
        </p:nvCxnSpPr>
        <p:spPr>
          <a:xfrm flipH="1" flipV="1">
            <a:off x="4393480" y="1404195"/>
            <a:ext cx="197895" cy="13607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Rectangle 27"/>
          <p:cNvSpPr/>
          <p:nvPr/>
        </p:nvSpPr>
        <p:spPr>
          <a:xfrm>
            <a:off x="3552962" y="1181788"/>
            <a:ext cx="61266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lb-LU" sz="800" dirty="0">
                <a:latin typeface="Arial" panose="020B0604020202020204" pitchFamily="34" charset="0"/>
              </a:rPr>
              <a:t>PDGFRA</a:t>
            </a:r>
            <a:endParaRPr lang="lb-LU" dirty="0"/>
          </a:p>
        </p:txBody>
      </p:sp>
      <p:cxnSp>
        <p:nvCxnSpPr>
          <p:cNvPr id="29" name="Straight Connector 28"/>
          <p:cNvCxnSpPr/>
          <p:nvPr/>
        </p:nvCxnSpPr>
        <p:spPr>
          <a:xfrm flipH="1" flipV="1">
            <a:off x="4078213" y="1295099"/>
            <a:ext cx="249619" cy="6935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ectangle 32"/>
          <p:cNvSpPr/>
          <p:nvPr/>
        </p:nvSpPr>
        <p:spPr>
          <a:xfrm>
            <a:off x="3691335" y="1064127"/>
            <a:ext cx="56297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lb-LU" sz="800" dirty="0">
                <a:latin typeface="Arial" panose="020B0604020202020204" pitchFamily="34" charset="0"/>
              </a:rPr>
              <a:t>NFE2L2</a:t>
            </a:r>
            <a:endParaRPr lang="lb-LU" dirty="0"/>
          </a:p>
        </p:txBody>
      </p:sp>
      <p:sp>
        <p:nvSpPr>
          <p:cNvPr id="34" name="Rectangle 33"/>
          <p:cNvSpPr/>
          <p:nvPr/>
        </p:nvSpPr>
        <p:spPr>
          <a:xfrm>
            <a:off x="4400364" y="978363"/>
            <a:ext cx="43152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lb-LU" sz="800" dirty="0">
                <a:latin typeface="Arial" panose="020B0604020202020204" pitchFamily="34" charset="0"/>
              </a:rPr>
              <a:t>TP53</a:t>
            </a:r>
            <a:endParaRPr lang="lb-LU" dirty="0"/>
          </a:p>
        </p:txBody>
      </p:sp>
      <p:sp>
        <p:nvSpPr>
          <p:cNvPr id="35" name="Rectangle 34"/>
          <p:cNvSpPr/>
          <p:nvPr/>
        </p:nvSpPr>
        <p:spPr>
          <a:xfrm>
            <a:off x="4114068" y="1003739"/>
            <a:ext cx="46038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lb-LU" sz="800" dirty="0">
                <a:latin typeface="Arial" panose="020B0604020202020204" pitchFamily="34" charset="0"/>
              </a:rPr>
              <a:t>SOX2</a:t>
            </a:r>
            <a:endParaRPr lang="lb-LU" dirty="0"/>
          </a:p>
        </p:txBody>
      </p:sp>
      <p:sp>
        <p:nvSpPr>
          <p:cNvPr id="36" name="Rectangle 35"/>
          <p:cNvSpPr/>
          <p:nvPr/>
        </p:nvSpPr>
        <p:spPr>
          <a:xfrm>
            <a:off x="4519252" y="1268382"/>
            <a:ext cx="51809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lb-LU" sz="800" dirty="0">
                <a:latin typeface="Arial" panose="020B0604020202020204" pitchFamily="34" charset="0"/>
              </a:rPr>
              <a:t>KEAP1</a:t>
            </a:r>
            <a:endParaRPr lang="lb-LU" dirty="0"/>
          </a:p>
        </p:txBody>
      </p:sp>
      <p:sp>
        <p:nvSpPr>
          <p:cNvPr id="37" name="Rectangle 36"/>
          <p:cNvSpPr/>
          <p:nvPr/>
        </p:nvSpPr>
        <p:spPr>
          <a:xfrm>
            <a:off x="4494056" y="781130"/>
            <a:ext cx="60144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lb-LU" sz="800" dirty="0">
                <a:latin typeface="Arial" panose="020B0604020202020204" pitchFamily="34" charset="0"/>
              </a:rPr>
              <a:t>CDKN2A</a:t>
            </a:r>
            <a:endParaRPr lang="lb-LU" dirty="0"/>
          </a:p>
        </p:txBody>
      </p:sp>
      <p:cxnSp>
        <p:nvCxnSpPr>
          <p:cNvPr id="38" name="Straight Connector 37"/>
          <p:cNvCxnSpPr/>
          <p:nvPr/>
        </p:nvCxnSpPr>
        <p:spPr>
          <a:xfrm flipV="1">
            <a:off x="4006267" y="1646606"/>
            <a:ext cx="104771" cy="33292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3936261" y="1540274"/>
            <a:ext cx="177807" cy="277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/>
          <p:cNvCxnSpPr/>
          <p:nvPr/>
        </p:nvCxnSpPr>
        <p:spPr>
          <a:xfrm flipH="1" flipV="1">
            <a:off x="4165631" y="1195817"/>
            <a:ext cx="309047" cy="9803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/>
          <p:cNvCxnSpPr/>
          <p:nvPr/>
        </p:nvCxnSpPr>
        <p:spPr>
          <a:xfrm flipH="1" flipV="1">
            <a:off x="4742173" y="1250426"/>
            <a:ext cx="17883" cy="4123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/>
          <p:cNvCxnSpPr/>
          <p:nvPr/>
        </p:nvCxnSpPr>
        <p:spPr>
          <a:xfrm flipV="1">
            <a:off x="4853083" y="968658"/>
            <a:ext cx="55237" cy="17974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/>
          <p:cNvCxnSpPr/>
          <p:nvPr/>
        </p:nvCxnSpPr>
        <p:spPr>
          <a:xfrm flipH="1" flipV="1">
            <a:off x="4452032" y="1161669"/>
            <a:ext cx="97148" cy="8823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/>
          <p:cNvCxnSpPr/>
          <p:nvPr/>
        </p:nvCxnSpPr>
        <p:spPr>
          <a:xfrm flipV="1">
            <a:off x="4579503" y="1129512"/>
            <a:ext cx="36625" cy="11349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87"/>
          <p:cNvSpPr txBox="1"/>
          <p:nvPr/>
        </p:nvSpPr>
        <p:spPr>
          <a:xfrm>
            <a:off x="349296" y="4636065"/>
            <a:ext cx="605536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8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Expression of oncogenes important for lung squamous cell carcinoma is concordant for the two platforms. Results are presented as average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logFC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between tumour and normal samples. Some oncogenes show only a small absolute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logFC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as they are mainly affected by mutations at DNA level.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2966899" y="3852336"/>
            <a:ext cx="1359668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NA-seq, log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C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 rot="16200000">
            <a:off x="1289820" y="2011225"/>
            <a:ext cx="103406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TA, log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C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514376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386080" y="5730556"/>
            <a:ext cx="608584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9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Variability in exon expression measured by RNA-seq and HTA platforms. Exon expression measured for one of the samples (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. Colours represent the gene length: blue – short, green – intermediate, red – long. Dependency between standard deviation and scaled mean expression for normal (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and tumour (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samples (obtained using the same approach as in Fig. S4 c-f).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261" y="704595"/>
            <a:ext cx="6405477" cy="48041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192592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598</TotalTime>
  <Words>1400</Words>
  <Application>Microsoft Office PowerPoint</Application>
  <PresentationFormat>A4 Paper (210x297 mm)</PresentationFormat>
  <Paragraphs>315</Paragraphs>
  <Slides>11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tr Nazarov</dc:creator>
  <cp:lastModifiedBy>Peter</cp:lastModifiedBy>
  <cp:revision>294</cp:revision>
  <cp:lastPrinted>2016-10-28T09:39:59Z</cp:lastPrinted>
  <dcterms:created xsi:type="dcterms:W3CDTF">2014-03-25T13:32:53Z</dcterms:created>
  <dcterms:modified xsi:type="dcterms:W3CDTF">2017-03-04T09:43:31Z</dcterms:modified>
</cp:coreProperties>
</file>